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  <p:sldMasterId id="2147483660" r:id="rId5"/>
  </p:sldMasterIdLst>
  <p:sldIdLst>
    <p:sldId id="265" r:id="rId6"/>
    <p:sldId id="264" r:id="rId7"/>
    <p:sldId id="256" r:id="rId8"/>
    <p:sldId id="257" r:id="rId9"/>
    <p:sldId id="258" r:id="rId10"/>
    <p:sldId id="259" r:id="rId11"/>
    <p:sldId id="260" r:id="rId12"/>
    <p:sldId id="261" r:id="rId13"/>
    <p:sldId id="262" r:id="rId14"/>
    <p:sldId id="263" r:id="rId15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14" y="2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presProps" Target="presProps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2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F6F1-D2FA-4FFB-94DC-640F05B6F3CE}" type="datetimeFigureOut">
              <a:rPr lang="nb-NO" smtClean="0"/>
              <a:t>02.08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517DA-5DD0-4CB3-9197-C7DA885C43D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58421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F6F1-D2FA-4FFB-94DC-640F05B6F3CE}" type="datetimeFigureOut">
              <a:rPr lang="nb-NO" smtClean="0"/>
              <a:t>02.08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517DA-5DD0-4CB3-9197-C7DA885C43D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22779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F6F1-D2FA-4FFB-94DC-640F05B6F3CE}" type="datetimeFigureOut">
              <a:rPr lang="nb-NO" smtClean="0"/>
              <a:t>02.08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517DA-5DD0-4CB3-9197-C7DA885C43D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2692383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49659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6733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2576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21942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799827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13888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04296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9916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F6F1-D2FA-4FFB-94DC-640F05B6F3CE}" type="datetimeFigureOut">
              <a:rPr lang="nb-NO" smtClean="0"/>
              <a:t>02.08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517DA-5DD0-4CB3-9197-C7DA885C43D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09534834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64018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818578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BEB17-76F5-4805-8A0A-899CE33FB652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2782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F6F1-D2FA-4FFB-94DC-640F05B6F3CE}" type="datetimeFigureOut">
              <a:rPr lang="nb-NO" smtClean="0"/>
              <a:t>02.08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517DA-5DD0-4CB3-9197-C7DA885C43D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41452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F6F1-D2FA-4FFB-94DC-640F05B6F3CE}" type="datetimeFigureOut">
              <a:rPr lang="nb-NO" smtClean="0"/>
              <a:t>02.08.2022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517DA-5DD0-4CB3-9197-C7DA885C43D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97097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F6F1-D2FA-4FFB-94DC-640F05B6F3CE}" type="datetimeFigureOut">
              <a:rPr lang="nb-NO" smtClean="0"/>
              <a:t>02.08.2022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517DA-5DD0-4CB3-9197-C7DA885C43D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43771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F6F1-D2FA-4FFB-94DC-640F05B6F3CE}" type="datetimeFigureOut">
              <a:rPr lang="nb-NO" smtClean="0"/>
              <a:t>02.08.2022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517DA-5DD0-4CB3-9197-C7DA885C43D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88001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F6F1-D2FA-4FFB-94DC-640F05B6F3CE}" type="datetimeFigureOut">
              <a:rPr lang="nb-NO" smtClean="0"/>
              <a:t>02.08.2022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517DA-5DD0-4CB3-9197-C7DA885C43D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45835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F6F1-D2FA-4FFB-94DC-640F05B6F3CE}" type="datetimeFigureOut">
              <a:rPr lang="nb-NO" smtClean="0"/>
              <a:t>02.08.2022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517DA-5DD0-4CB3-9197-C7DA885C43D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664181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8CF6F1-D2FA-4FFB-94DC-640F05B6F3CE}" type="datetimeFigureOut">
              <a:rPr lang="nb-NO" smtClean="0"/>
              <a:t>02.08.2022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8517DA-5DD0-4CB3-9197-C7DA885C43D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9639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8CF6F1-D2FA-4FFB-94DC-640F05B6F3CE}" type="datetimeFigureOut">
              <a:rPr lang="nb-NO" smtClean="0"/>
              <a:t>02.08.2022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8517DA-5DD0-4CB3-9197-C7DA885C43D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39946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BEB17-76F5-4805-8A0A-899CE33FB652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99B435-FB82-4E4E-B850-37AD232016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869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andreas.koutroulis@odont.uio.no" TargetMode="External"/><Relationship Id="rId1" Type="http://schemas.openxmlformats.org/officeDocument/2006/relationships/slideLayout" Target="../slideLayouts/slideLayout13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emf"/><Relationship Id="rId7" Type="http://schemas.openxmlformats.org/officeDocument/2006/relationships/image" Target="../media/image48.emf"/><Relationship Id="rId2" Type="http://schemas.openxmlformats.org/officeDocument/2006/relationships/image" Target="../media/image4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emf"/><Relationship Id="rId5" Type="http://schemas.openxmlformats.org/officeDocument/2006/relationships/image" Target="../media/image46.emf"/><Relationship Id="rId4" Type="http://schemas.openxmlformats.org/officeDocument/2006/relationships/image" Target="../media/image45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7" Type="http://schemas.openxmlformats.org/officeDocument/2006/relationships/image" Target="../media/image24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emf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7" Type="http://schemas.openxmlformats.org/officeDocument/2006/relationships/image" Target="../media/image30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emf"/><Relationship Id="rId5" Type="http://schemas.openxmlformats.org/officeDocument/2006/relationships/image" Target="../media/image28.emf"/><Relationship Id="rId4" Type="http://schemas.openxmlformats.org/officeDocument/2006/relationships/image" Target="../media/image27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7" Type="http://schemas.openxmlformats.org/officeDocument/2006/relationships/image" Target="../media/image36.emf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emf"/><Relationship Id="rId5" Type="http://schemas.openxmlformats.org/officeDocument/2006/relationships/image" Target="../media/image34.emf"/><Relationship Id="rId4" Type="http://schemas.openxmlformats.org/officeDocument/2006/relationships/image" Target="../media/image33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7" Type="http://schemas.openxmlformats.org/officeDocument/2006/relationships/image" Target="../media/image42.emf"/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emf"/><Relationship Id="rId5" Type="http://schemas.openxmlformats.org/officeDocument/2006/relationships/image" Target="../media/image40.emf"/><Relationship Id="rId4" Type="http://schemas.openxmlformats.org/officeDocument/2006/relationships/image" Target="../media/image3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74776" y="1386713"/>
            <a:ext cx="10515600" cy="4351338"/>
          </a:xfrm>
        </p:spPr>
        <p:txBody>
          <a:bodyPr>
            <a:normAutofit/>
          </a:bodyPr>
          <a:lstStyle/>
          <a:p>
            <a:pPr marL="0" indent="0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rface characteristics and bacterial adhesion of endodontic </a:t>
            </a:r>
            <a:r>
              <a:rPr lang="en-US" sz="20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ments </a:t>
            </a:r>
          </a:p>
          <a:p>
            <a:pPr marL="0" indent="0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sz="16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inical Oral Investigations</a:t>
            </a:r>
          </a:p>
          <a:p>
            <a:pPr marL="0" indent="0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outroulis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.V. </a:t>
            </a:r>
            <a:r>
              <a:rPr lang="en-US" sz="14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ukke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Ørstavik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apralos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milleri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T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nde</a:t>
            </a:r>
            <a:endParaRPr lang="nb-NO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50000"/>
              </a:lnSpc>
              <a:buNone/>
            </a:pPr>
            <a:r>
              <a:rPr lang="en-US" sz="1200" dirty="0">
                <a:latin typeface="Times New Roman" panose="02020603050405020304" pitchFamily="18" charset="0"/>
              </a:rPr>
              <a:t>Section of Endodontics, Institute of Clinical Dentistry, Faculty of Dentistry, University of </a:t>
            </a:r>
            <a:r>
              <a:rPr lang="en-US" sz="1200" dirty="0" smtClean="0">
                <a:latin typeface="Times New Roman" panose="02020603050405020304" pitchFamily="18" charset="0"/>
              </a:rPr>
              <a:t>Oslo, Oslo, Norway</a:t>
            </a:r>
            <a:endParaRPr lang="nb-NO" sz="1200" dirty="0"/>
          </a:p>
          <a:p>
            <a:pPr marL="0" indent="0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-mail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ress: </a:t>
            </a:r>
            <a:r>
              <a:rPr lang="en-US" sz="1200" u="sng" dirty="0">
                <a:solidFill>
                  <a:srgbClr val="0563C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andreas.koutroulis@odont.uio.no</a:t>
            </a:r>
            <a:endParaRPr lang="nb-NO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800"/>
              </a:spcAft>
            </a:pPr>
            <a:endParaRPr lang="nb-NO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5354662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4400" y="1026000"/>
            <a:ext cx="3308482" cy="24480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26400" y="1026000"/>
            <a:ext cx="3308481" cy="24480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22000" y="1026000"/>
            <a:ext cx="3308482" cy="24480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4400" y="3517200"/>
            <a:ext cx="3308482" cy="24480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26400" y="3517200"/>
            <a:ext cx="3308482" cy="24480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22000" y="3517200"/>
            <a:ext cx="3308481" cy="244800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5074595" y="260132"/>
            <a:ext cx="16141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RM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984518" y="741600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479433" y="741600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8974347" y="741633"/>
            <a:ext cx="9067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8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-30006" y="2139818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er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-2574" y="4587818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B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50734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801255" y="1094295"/>
            <a:ext cx="10515600" cy="1508759"/>
          </a:xfrm>
        </p:spPr>
        <p:txBody>
          <a:bodyPr>
            <a:noAutofit/>
          </a:bodyPr>
          <a:lstStyle/>
          <a:p>
            <a:pPr>
              <a:lnSpc>
                <a:spcPct val="200000"/>
              </a:lnSpc>
            </a:pPr>
            <a:r>
              <a:rPr lang="nb-NO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line Resource 2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s acquired after stereoscopic reconstruction of scanning electron micrographs obtained with a quad-type backscatter electron detector at 200× magnification. Materials were exposure to ultrapure water (water) or Fetal Bovine Serum (FBS) for 1, 7 or 28 days prior to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in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urs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 represent height (mm) as indicated in the scale bars on the right side of each image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663972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505" y="1027428"/>
            <a:ext cx="3308481" cy="24480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57419" y="1027428"/>
            <a:ext cx="3308482" cy="244800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52334" y="1027428"/>
            <a:ext cx="3308482" cy="244800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2505" y="3517707"/>
            <a:ext cx="3308481" cy="244800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57419" y="3517707"/>
            <a:ext cx="3308482" cy="244800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52334" y="3517707"/>
            <a:ext cx="3308481" cy="2448000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5104601" y="260132"/>
            <a:ext cx="16141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Z-base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014524" y="741600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509439" y="741600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9004353" y="741633"/>
            <a:ext cx="9700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8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0" y="2139818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er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7432" y="4587818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B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08789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4400" y="1026000"/>
            <a:ext cx="3308480" cy="2448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26400" y="1026000"/>
            <a:ext cx="3308481" cy="24480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22000" y="1026000"/>
            <a:ext cx="3308481" cy="24480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4400" y="3517200"/>
            <a:ext cx="3308481" cy="244800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26400" y="3517200"/>
            <a:ext cx="3308480" cy="244800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22000" y="3517200"/>
            <a:ext cx="3308481" cy="244800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5074595" y="260132"/>
            <a:ext cx="16141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Z-bg10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984518" y="741600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nb-NO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y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479433" y="741600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nb-NO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y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8974347" y="741633"/>
            <a:ext cx="9534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8 </a:t>
            </a:r>
            <a:r>
              <a:rPr lang="nb-NO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y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-30006" y="2139818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er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-2574" y="4587818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B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88719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4400" y="1026000"/>
            <a:ext cx="3308482" cy="24480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26400" y="1026000"/>
            <a:ext cx="3308482" cy="24480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22000" y="1026000"/>
            <a:ext cx="3308482" cy="24480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4400" y="3517200"/>
            <a:ext cx="3308481" cy="24480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26400" y="3517200"/>
            <a:ext cx="3308482" cy="24480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22000" y="3517200"/>
            <a:ext cx="3308480" cy="244800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5074595" y="260132"/>
            <a:ext cx="16141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Z-bg20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984518" y="741600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479433" y="741600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8974347" y="741633"/>
            <a:ext cx="9067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8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-30006" y="2139818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er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-2574" y="4587818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B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631051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4400" y="1026000"/>
            <a:ext cx="3308481" cy="24480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26400" y="1026000"/>
            <a:ext cx="3308481" cy="24480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22000" y="1026000"/>
            <a:ext cx="3308482" cy="24480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4400" y="3517200"/>
            <a:ext cx="3308481" cy="24480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26400" y="3517200"/>
            <a:ext cx="3308481" cy="24480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22000" y="3517200"/>
            <a:ext cx="3308481" cy="244800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5074595" y="260132"/>
            <a:ext cx="16141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Z-Ag0.5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984518" y="741600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479433" y="741600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8974347" y="741633"/>
            <a:ext cx="9161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8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-30006" y="2139818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er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-2574" y="4587818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B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63028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4400" y="1026000"/>
            <a:ext cx="3308481" cy="24480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26400" y="1026000"/>
            <a:ext cx="3308482" cy="24480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22000" y="1026000"/>
            <a:ext cx="3308481" cy="24480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4400" y="3517200"/>
            <a:ext cx="3308482" cy="24480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26400" y="3517200"/>
            <a:ext cx="3308481" cy="24480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22000" y="3517200"/>
            <a:ext cx="3308482" cy="244800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5074595" y="260132"/>
            <a:ext cx="16141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Z-Ag1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984518" y="741600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479433" y="741600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8974347" y="741633"/>
            <a:ext cx="8787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8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-30006" y="2139818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er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-2574" y="4587818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B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6022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4400" y="1026000"/>
            <a:ext cx="3308481" cy="24480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26400" y="1026000"/>
            <a:ext cx="3308481" cy="24480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22000" y="1026000"/>
            <a:ext cx="3308482" cy="24480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4400" y="3517200"/>
            <a:ext cx="3308481" cy="24480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26400" y="3517200"/>
            <a:ext cx="3308480" cy="24480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22000" y="3517200"/>
            <a:ext cx="3308482" cy="244800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5074595" y="260132"/>
            <a:ext cx="16141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Z-Ag2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984518" y="741600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479433" y="741600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8974347" y="741633"/>
            <a:ext cx="9067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8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-30006" y="2139818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er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-2574" y="4587818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B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146504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4400" y="1026000"/>
            <a:ext cx="3308481" cy="24480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22000" y="1026000"/>
            <a:ext cx="3308482" cy="24480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26400" y="1026000"/>
            <a:ext cx="3308481" cy="24480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4400" y="3517200"/>
            <a:ext cx="3308481" cy="24480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26400" y="3517200"/>
            <a:ext cx="3308481" cy="244800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22000" y="3517200"/>
            <a:ext cx="3308481" cy="244800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5074595" y="260132"/>
            <a:ext cx="16141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odentine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984518" y="741600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479433" y="741600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8974347" y="741633"/>
            <a:ext cx="897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8 </a:t>
            </a:r>
            <a:r>
              <a:rPr lang="nb-NO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-30006" y="2139818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er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-2574" y="4587818"/>
            <a:ext cx="804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BS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0132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7867A5ACEDE7C46879FD70367F61781" ma:contentTypeVersion="4" ma:contentTypeDescription="Create a new document." ma:contentTypeScope="" ma:versionID="4725c9e020c5869f28d6a4aa28e35a24">
  <xsd:schema xmlns:xsd="http://www.w3.org/2001/XMLSchema" xmlns:xs="http://www.w3.org/2001/XMLSchema" xmlns:p="http://schemas.microsoft.com/office/2006/metadata/properties" xmlns:ns2="ae4ed773-a29c-4530-bc0b-fc53d9223a14" targetNamespace="http://schemas.microsoft.com/office/2006/metadata/properties" ma:root="true" ma:fieldsID="925b2d4885457ae81849ff362489b00d" ns2:_="">
    <xsd:import namespace="ae4ed773-a29c-4530-bc0b-fc53d9223a14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e4ed773-a29c-4530-bc0b-fc53d9223a1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5FEF6B30-C69C-498E-80D7-48A1A8AF4AFF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13CA6AC4-ACCB-4634-A6CB-8D87E28F1B04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183B540F-11EE-4511-8E24-BC33D88B373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e4ed773-a29c-4530-bc0b-fc53d9223a1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14</TotalTime>
  <Words>202</Words>
  <Application>Microsoft Office PowerPoint</Application>
  <PresentationFormat>Widescreen</PresentationFormat>
  <Paragraphs>54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1_Office Theme</vt:lpstr>
      <vt:lpstr>PowerPoint Presentation</vt:lpstr>
      <vt:lpstr>Online Resource 2 Representative images acquired after stereoscopic reconstruction of scanning electron micrographs obtained with a quad-type backscatter electron detector at 200× magnification. Materials were exposure to ultrapure water (water) or Fetal Bovine Serum (FBS) for 1, 7 or 28 days prior to testing. Colours represent height (mm) as indicated in the scale bars on the right side of each image.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etet i Osl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as Koutroulis</dc:creator>
  <cp:lastModifiedBy>Andreas Koutroulis</cp:lastModifiedBy>
  <cp:revision>47</cp:revision>
  <dcterms:created xsi:type="dcterms:W3CDTF">2021-01-19T13:08:16Z</dcterms:created>
  <dcterms:modified xsi:type="dcterms:W3CDTF">2022-08-02T14:08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7867A5ACEDE7C46879FD70367F61781</vt:lpwstr>
  </property>
</Properties>
</file>